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1" r:id="rId2"/>
    <p:sldId id="264" r:id="rId3"/>
    <p:sldId id="26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0000"/>
  </p:normalViewPr>
  <p:slideViewPr>
    <p:cSldViewPr snapToGrid="0">
      <p:cViewPr varScale="1">
        <p:scale>
          <a:sx n="114" d="100"/>
          <a:sy n="114" d="100"/>
        </p:scale>
        <p:origin x="57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192FCE-B044-CF44-95A0-88356D011018}" type="datetimeFigureOut">
              <a:rPr lang="en-US" smtClean="0"/>
              <a:t>7/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6859C5-A2A2-E04F-B345-387DB2A39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539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0F2052-97BF-B24E-A719-4467A9121F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0610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0F2052-97BF-B24E-A719-4467A9121F7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3992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3D1A7-8B33-2A9C-3D79-2D8CA5585B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0A1BEC-8D42-DD58-6B21-FE5BE5ED82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85B64-13E5-FC73-8CE0-BA6B2F94E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446F76-F51B-C761-AF57-8EF31A675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14D741-6FF7-90E7-F768-280CAF946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96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A75FA-CAEE-D75A-BAAF-C6E65F2E6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F4055B-2F6F-E0FA-B1D0-AF81383308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D9E1F5-914C-8ED7-95DF-0D6C08C23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26D88-1D03-9BC3-D248-A4659EAFE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8B359-425E-8152-42CC-632AEA9CC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213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6B629E-9F22-C809-283A-451EB6B08C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71975D-2D40-AEDE-E2DC-EB92B587A8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C72ACC-0A8C-EF01-4186-D639257BA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8A1C44-20FB-4703-6858-1941698F7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45E9C-CCDF-9903-0F5E-B14C94A54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466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F5990-0107-A0FF-5367-4DFCB9932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53629E-8FF8-05C4-EFFF-AF14723254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A36B90-F159-0FD5-278A-5330BFC23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572EB7-23A4-7020-28B7-9DE84BC78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8C029A-D067-C1A4-1D75-9520A2E00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224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533D7-06AD-F6BC-D2FE-F58AFB06A1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F3A8E7-2665-288A-658B-6D5DB1B5FD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0571B-D2A2-BB9E-A670-2145182FC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EBE870-8E3D-F72F-5132-37A71BF48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CA445-7F5D-FE0F-B171-02D354930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530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7A843D-F6D6-C6BD-09F6-263E6B7C01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A3ACCE-5729-5321-370E-CFB1965225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9CCFD7-B5D5-1DBC-2E21-B3954D476E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3EB108-18E1-95F1-4294-D480CEA01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207551-D9C7-09AB-50C8-C2201EF6B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E6AAD4-5F7C-531A-97AA-6B21A31E2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46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5B0AD-D30D-AB8C-C998-7868DC5E1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A7D5E1-BC31-1841-B4B5-2EA6A9064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856AA5-0303-674F-8394-9B3CFCF3B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3D93B5-220C-0E80-C13B-990A66DE6B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7D25F5-3CB0-1FC2-0F48-947AC62E2E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8DEEC5-0475-C38A-EDF6-0FBE5852E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1A1346-A7F2-65C5-7012-15457D8A5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F87335-A646-B213-1C10-1C98A9B95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61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36D62-2F92-7C47-A682-5DD3FF09A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F44F52-DDB7-9A97-2CD7-7AEA8B0E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9C29F9-C396-0EF2-A613-986A87365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756CFD-3016-E9A2-6674-4E5ABD61F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07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064A98-4F84-0EF5-438E-6011F989B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688B85-CE20-15C9-888C-C03130E7E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4A0964-1865-AA71-D53A-F5559FE52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484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3EAC3-70B2-795F-A5B5-F019BB298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C90194-456A-1377-364B-6B87C73EB2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C0F954-9B7B-9A5B-3CEF-005AD1635C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D27A72-B049-163B-4636-0C93895D0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B3A693-39DC-485F-899E-4125022EE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EF0EA4-C4AE-BF39-E913-50F53C1F8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33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FDB27-F929-705B-193B-085DF717F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34819E-0C79-2193-75A4-BE774C3495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107EB6-73C7-8B94-7F00-B69071606A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7E8051-FA1E-FC29-8974-E3EBDFB5C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1DBF45-353E-B306-1AD0-95D4A4E17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4AB019-9AAD-5DB4-CE51-D5E0BBB21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452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1A9CC2-5697-6C98-BA4E-D15CFBEA0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5FBF7C-91BA-9E64-8C01-5C7B4D621F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1081D5-4F36-F5A5-2310-69C2684B75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2050F4-33D5-CE82-FD97-3FA0EBBAA9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954360-1CEE-ADBB-F6F0-B9E3C0941F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411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17E4C75-2285-B92A-A857-07A732F0F02E}"/>
              </a:ext>
            </a:extLst>
          </p:cNvPr>
          <p:cNvSpPr/>
          <p:nvPr/>
        </p:nvSpPr>
        <p:spPr>
          <a:xfrm>
            <a:off x="11283696" y="5230368"/>
            <a:ext cx="100584" cy="2194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59102FF-2D0B-D8EE-710A-DECABF1011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9949" y="260349"/>
            <a:ext cx="10878705" cy="6595957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B3559096-A2D0-3D1E-13C3-3871B59F8C7C}"/>
              </a:ext>
            </a:extLst>
          </p:cNvPr>
          <p:cNvSpPr/>
          <p:nvPr/>
        </p:nvSpPr>
        <p:spPr>
          <a:xfrm>
            <a:off x="1567543" y="385200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E3DDA6B-A80D-81F7-29A7-D7C3FEFD3F4D}"/>
              </a:ext>
            </a:extLst>
          </p:cNvPr>
          <p:cNvSpPr/>
          <p:nvPr/>
        </p:nvSpPr>
        <p:spPr>
          <a:xfrm>
            <a:off x="6901543" y="356171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794AA3C-0AF4-95E6-20E5-EBBD8D2B07AC}"/>
              </a:ext>
            </a:extLst>
          </p:cNvPr>
          <p:cNvSpPr/>
          <p:nvPr/>
        </p:nvSpPr>
        <p:spPr>
          <a:xfrm>
            <a:off x="1596571" y="3577209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5DFE731-1990-1DD8-9963-989F11BBDF2D}"/>
              </a:ext>
            </a:extLst>
          </p:cNvPr>
          <p:cNvSpPr/>
          <p:nvPr/>
        </p:nvSpPr>
        <p:spPr>
          <a:xfrm>
            <a:off x="6930571" y="3548180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0F9C33-1BAD-BF93-3BDF-703F4B9AE9A1}"/>
              </a:ext>
            </a:extLst>
          </p:cNvPr>
          <p:cNvSpPr txBox="1"/>
          <p:nvPr/>
        </p:nvSpPr>
        <p:spPr>
          <a:xfrm>
            <a:off x="771525" y="15868"/>
            <a:ext cx="48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3321808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361EE47B-AEBA-25E8-3A0B-9FCBAB30EE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7820" y="267351"/>
            <a:ext cx="10702381" cy="648904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D659D7F-EEA6-3686-CF87-A2337586E6BF}"/>
              </a:ext>
            </a:extLst>
          </p:cNvPr>
          <p:cNvSpPr txBox="1"/>
          <p:nvPr/>
        </p:nvSpPr>
        <p:spPr>
          <a:xfrm>
            <a:off x="442045" y="138545"/>
            <a:ext cx="48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3488570-8420-216C-5712-DB71DB84F42D}"/>
              </a:ext>
            </a:extLst>
          </p:cNvPr>
          <p:cNvSpPr/>
          <p:nvPr/>
        </p:nvSpPr>
        <p:spPr>
          <a:xfrm>
            <a:off x="1596571" y="398018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9FDCD64-F4F4-E10D-BB94-F9B12234C3A2}"/>
              </a:ext>
            </a:extLst>
          </p:cNvPr>
          <p:cNvSpPr/>
          <p:nvPr/>
        </p:nvSpPr>
        <p:spPr>
          <a:xfrm>
            <a:off x="6901543" y="356171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D18CF7B-0F7D-F0F8-F63E-2EF62DAD9924}"/>
              </a:ext>
            </a:extLst>
          </p:cNvPr>
          <p:cNvSpPr/>
          <p:nvPr/>
        </p:nvSpPr>
        <p:spPr>
          <a:xfrm>
            <a:off x="1596571" y="3577209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440A5FF-E626-FAC4-8351-F83E48BC067D}"/>
              </a:ext>
            </a:extLst>
          </p:cNvPr>
          <p:cNvSpPr/>
          <p:nvPr/>
        </p:nvSpPr>
        <p:spPr>
          <a:xfrm>
            <a:off x="6930571" y="3548180"/>
            <a:ext cx="217714" cy="2389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77E9B54-FEBC-A5B8-2295-445604DBE61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6246" t="18567" r="53362" b="77242"/>
          <a:stretch>
            <a:fillRect/>
          </a:stretch>
        </p:blipFill>
        <p:spPr>
          <a:xfrm>
            <a:off x="4965405" y="1435396"/>
            <a:ext cx="1130595" cy="27644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61239E0-1BF3-41E4-45CE-2E8695877E4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6246" t="18567" r="53362" b="77242"/>
          <a:stretch>
            <a:fillRect/>
          </a:stretch>
        </p:blipFill>
        <p:spPr>
          <a:xfrm>
            <a:off x="4965404" y="4639340"/>
            <a:ext cx="1130595" cy="27644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C5AFA54-ACE9-1535-E49D-DBE12BAE25D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6246" t="18567" r="53362" b="77242"/>
          <a:stretch>
            <a:fillRect/>
          </a:stretch>
        </p:blipFill>
        <p:spPr>
          <a:xfrm>
            <a:off x="10224716" y="4639340"/>
            <a:ext cx="1130595" cy="27644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9E87EAA-0BF3-06C0-A54B-F7ABC3D5C61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6246" t="18567" r="53362" b="77242"/>
          <a:stretch>
            <a:fillRect/>
          </a:stretch>
        </p:blipFill>
        <p:spPr>
          <a:xfrm>
            <a:off x="10289528" y="1417675"/>
            <a:ext cx="1130595" cy="2764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42353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71734A7-78B6-4945-9080-5FB218A3A27C}"/>
              </a:ext>
            </a:extLst>
          </p:cNvPr>
          <p:cNvSpPr txBox="1"/>
          <p:nvPr/>
        </p:nvSpPr>
        <p:spPr>
          <a:xfrm>
            <a:off x="0" y="0"/>
            <a:ext cx="121920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Association of Baseline Clinical Characteristics with Plasma and Oral Gargle HPV DNA Status. 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ar charts show the comparison of proportions of patients with A) detectable versus undetectable baseline plasma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fHPV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NA or B) detectable versus undetectable baseline oral gargle HPV DNA stratified by key baseline clinical variable groups. P-values represent Fisher’s Exact Tests where p&lt;0.05 is considered significant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b="1" kern="1200" dirty="0"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47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</TotalTime>
  <Words>75</Words>
  <Application>Microsoft Macintosh PowerPoint</Application>
  <PresentationFormat>Widescreen</PresentationFormat>
  <Paragraphs>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bin Park</dc:creator>
  <cp:lastModifiedBy>Robin Park</cp:lastModifiedBy>
  <cp:revision>18</cp:revision>
  <dcterms:created xsi:type="dcterms:W3CDTF">2025-06-06T20:18:21Z</dcterms:created>
  <dcterms:modified xsi:type="dcterms:W3CDTF">2025-07-09T00:32:55Z</dcterms:modified>
</cp:coreProperties>
</file>